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21" autoAdjust="0"/>
    <p:restoredTop sz="94660"/>
  </p:normalViewPr>
  <p:slideViewPr>
    <p:cSldViewPr>
      <p:cViewPr>
        <p:scale>
          <a:sx n="65" d="100"/>
          <a:sy n="65" d="100"/>
        </p:scale>
        <p:origin x="-271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804B4-732F-4007-86F0-0525F51973A5}" type="datetimeFigureOut">
              <a:rPr lang="zh-CN" altLang="en-US" smtClean="0"/>
              <a:pPr/>
              <a:t>2023/9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B6768-E04A-483A-86C0-EAE291C903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05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hteck 16"/>
          <p:cNvSpPr/>
          <p:nvPr/>
        </p:nvSpPr>
        <p:spPr>
          <a:xfrm>
            <a:off x="1891560" y="9129464"/>
            <a:ext cx="3074881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3290BF09-F85B-AD54-25C4-BE6B6433BF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648" y="342286"/>
            <a:ext cx="4248472" cy="299178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8A750BA0-B7D3-648E-477A-02ECD44920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798" y="3679172"/>
            <a:ext cx="2160000" cy="216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019D6355-6784-4066-60CC-F1D857CE40B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9120" y="3679172"/>
            <a:ext cx="2160000" cy="216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88021425-FB74-F703-1BEB-1769E6E40F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53376" y="3679172"/>
            <a:ext cx="2160000" cy="216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514D7069-61ED-12AF-570C-38C9AE672AB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248" y="6177376"/>
            <a:ext cx="2160000" cy="2160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65916B0E-BC3C-19AA-5933-5F9C7A8685F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49120" y="6177376"/>
            <a:ext cx="2160000" cy="2160000"/>
          </a:xfrm>
          <a:prstGeom prst="rect">
            <a:avLst/>
          </a:prstGeom>
        </p:spPr>
      </p:pic>
      <p:sp>
        <p:nvSpPr>
          <p:cNvPr id="14" name="TextBox 18">
            <a:extLst>
              <a:ext uri="{FF2B5EF4-FFF2-40B4-BE49-F238E27FC236}">
                <a16:creationId xmlns:a16="http://schemas.microsoft.com/office/drawing/2014/main" xmlns="" id="{060A333C-125D-5B5E-C457-2E891353F904}"/>
              </a:ext>
            </a:extLst>
          </p:cNvPr>
          <p:cNvSpPr txBox="1"/>
          <p:nvPr/>
        </p:nvSpPr>
        <p:spPr>
          <a:xfrm>
            <a:off x="50324" y="217262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8">
            <a:extLst>
              <a:ext uri="{FF2B5EF4-FFF2-40B4-BE49-F238E27FC236}">
                <a16:creationId xmlns:a16="http://schemas.microsoft.com/office/drawing/2014/main" xmlns="" id="{1255011C-0AE2-1286-E2DB-EA5F45FB450E}"/>
              </a:ext>
            </a:extLst>
          </p:cNvPr>
          <p:cNvSpPr txBox="1"/>
          <p:nvPr/>
        </p:nvSpPr>
        <p:spPr>
          <a:xfrm>
            <a:off x="119482" y="3152800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8997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0688" y="992560"/>
            <a:ext cx="5688632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. The selection of yellow module genes by WGCNA in TCGA-LUSC.</a:t>
            </a:r>
            <a:endParaRPr lang="en-US" dirty="0"/>
          </a:p>
          <a:p>
            <a:r>
              <a:rPr lang="en-US" dirty="0"/>
              <a:t>The soft-thresholding power of 5 was selected based on the scale-free topology criterion in TCGA-LUSC (A). Scatter plots of the module membership (MM) and multi-estimated CAFs signatures as well as stromal score in the yellow module of TCGA-LUSC (B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989778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</TotalTime>
  <Words>65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Karthikeyan S</cp:lastModifiedBy>
  <cp:revision>537</cp:revision>
  <dcterms:created xsi:type="dcterms:W3CDTF">2019-03-24T15:08:43Z</dcterms:created>
  <dcterms:modified xsi:type="dcterms:W3CDTF">2023-09-04T14:06:06Z</dcterms:modified>
</cp:coreProperties>
</file>